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1" d="100"/>
          <a:sy n="81" d="100"/>
        </p:scale>
        <p:origin x="-1104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EAFC9C-29A1-4D81-B194-22A3839614F7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04849-2E57-4BA8-BEDF-5674D671320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159205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EAFC9C-29A1-4D81-B194-22A3839614F7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04849-2E57-4BA8-BEDF-5674D671320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192577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EAFC9C-29A1-4D81-B194-22A3839614F7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04849-2E57-4BA8-BEDF-5674D671320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677556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EAFC9C-29A1-4D81-B194-22A3839614F7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04849-2E57-4BA8-BEDF-5674D671320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76915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EAFC9C-29A1-4D81-B194-22A3839614F7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04849-2E57-4BA8-BEDF-5674D671320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893809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EAFC9C-29A1-4D81-B194-22A3839614F7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04849-2E57-4BA8-BEDF-5674D671320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928932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EAFC9C-29A1-4D81-B194-22A3839614F7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04849-2E57-4BA8-BEDF-5674D671320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527126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EAFC9C-29A1-4D81-B194-22A3839614F7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04849-2E57-4BA8-BEDF-5674D671320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573758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EAFC9C-29A1-4D81-B194-22A3839614F7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04849-2E57-4BA8-BEDF-5674D671320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917951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EAFC9C-29A1-4D81-B194-22A3839614F7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04849-2E57-4BA8-BEDF-5674D671320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66689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EAFC9C-29A1-4D81-B194-22A3839614F7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804849-2E57-4BA8-BEDF-5674D671320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609921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EAFC9C-29A1-4D81-B194-22A3839614F7}" type="datetimeFigureOut">
              <a:rPr lang="en-IN" smtClean="0"/>
              <a:t>02-09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804849-2E57-4BA8-BEDF-5674D671320D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734063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Rectangle 18"/>
          <p:cNvSpPr/>
          <p:nvPr/>
        </p:nvSpPr>
        <p:spPr>
          <a:xfrm>
            <a:off x="139424" y="4816900"/>
            <a:ext cx="9004576" cy="439579"/>
          </a:xfrm>
          <a:prstGeom prst="rect">
            <a:avLst/>
          </a:prstGeom>
        </p:spPr>
        <p:txBody>
          <a:bodyPr wrap="square" lIns="69568" tIns="34784" rIns="69568" bIns="34784">
            <a:spAutoFit/>
          </a:bodyPr>
          <a:lstStyle/>
          <a:p>
            <a:pPr marL="447675" indent="-447675"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4:  Figure S1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hematic diagram showing the different parts of the typical OL female reproductive organ (pistil). The letters a, b, c, d, e, and f denote non-brushy parts of the stigma, brushy parts of the stigma, stigma, style, ovary, and pistil, respectively.</a:t>
            </a:r>
            <a:endParaRPr lang="en-PH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0" name="Group 19"/>
          <p:cNvGrpSpPr/>
          <p:nvPr/>
        </p:nvGrpSpPr>
        <p:grpSpPr>
          <a:xfrm>
            <a:off x="2499147" y="1025128"/>
            <a:ext cx="3435432" cy="3120192"/>
            <a:chOff x="2294020" y="1748588"/>
            <a:chExt cx="4957554" cy="3553328"/>
          </a:xfrm>
        </p:grpSpPr>
        <p:pic>
          <p:nvPicPr>
            <p:cNvPr id="21" name="Picture 2" descr="E:\Out Crossing\1_Outcrossing Floral Photgaphs_Feb 2012 to Dec 2014\4_Wet Season 2013\2_Sept_2013\02-09\16B-WH13- 4997-11-20X-2.jpg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175" t="14431" r="13637" b="10357"/>
            <a:stretch>
              <a:fillRect/>
            </a:stretch>
          </p:blipFill>
          <p:spPr bwMode="auto">
            <a:xfrm>
              <a:off x="2294020" y="1748588"/>
              <a:ext cx="4411579" cy="35533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22" name="Straight Arrow Connector 21"/>
            <p:cNvCxnSpPr/>
            <p:nvPr/>
          </p:nvCxnSpPr>
          <p:spPr>
            <a:xfrm flipV="1">
              <a:off x="4624326" y="2382421"/>
              <a:ext cx="2085975" cy="1914526"/>
            </a:xfrm>
            <a:prstGeom prst="straightConnector1">
              <a:avLst/>
            </a:prstGeom>
            <a:ln>
              <a:solidFill>
                <a:schemeClr val="tx1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Arrow Connector 22"/>
            <p:cNvCxnSpPr/>
            <p:nvPr/>
          </p:nvCxnSpPr>
          <p:spPr>
            <a:xfrm flipV="1">
              <a:off x="4876800" y="2581274"/>
              <a:ext cx="2085975" cy="1914525"/>
            </a:xfrm>
            <a:prstGeom prst="straightConnector1">
              <a:avLst/>
            </a:prstGeom>
            <a:ln>
              <a:solidFill>
                <a:schemeClr val="tx1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Arrow Connector 23"/>
            <p:cNvCxnSpPr/>
            <p:nvPr/>
          </p:nvCxnSpPr>
          <p:spPr>
            <a:xfrm>
              <a:off x="4095750" y="4324349"/>
              <a:ext cx="9525" cy="323851"/>
            </a:xfrm>
            <a:prstGeom prst="straightConnector1">
              <a:avLst/>
            </a:prstGeom>
            <a:ln>
              <a:solidFill>
                <a:schemeClr val="tx1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/>
            <p:cNvCxnSpPr/>
            <p:nvPr/>
          </p:nvCxnSpPr>
          <p:spPr>
            <a:xfrm>
              <a:off x="5064931" y="3612335"/>
              <a:ext cx="500722" cy="32313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 Box 17"/>
            <p:cNvSpPr txBox="1">
              <a:spLocks noChangeArrowheads="1"/>
            </p:cNvSpPr>
            <p:nvPr/>
          </p:nvSpPr>
          <p:spPr bwMode="auto">
            <a:xfrm>
              <a:off x="5895251" y="3045167"/>
              <a:ext cx="277787" cy="396931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numCol="1" anchor="t" anchorCtr="0" compatLnSpc="1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PH" altLang="en-US" sz="16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b</a:t>
              </a:r>
              <a:endParaRPr kumimoji="0" lang="en-PH" altLang="en-U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Text Box 17"/>
            <p:cNvSpPr txBox="1">
              <a:spLocks noChangeArrowheads="1"/>
            </p:cNvSpPr>
            <p:nvPr/>
          </p:nvSpPr>
          <p:spPr bwMode="auto">
            <a:xfrm>
              <a:off x="5780893" y="3538536"/>
              <a:ext cx="277787" cy="396931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numCol="1" anchor="t" anchorCtr="0" compatLnSpc="1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lang="en-PH" alt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kumimoji="0" lang="en-PH" altLang="en-U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Text Box 17"/>
            <p:cNvSpPr txBox="1">
              <a:spLocks noChangeArrowheads="1"/>
            </p:cNvSpPr>
            <p:nvPr/>
          </p:nvSpPr>
          <p:spPr bwMode="auto">
            <a:xfrm>
              <a:off x="3817963" y="4306644"/>
              <a:ext cx="277787" cy="396931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numCol="1" anchor="t" anchorCtr="0" compatLnSpc="1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lang="en-PH" altLang="en-US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kumimoji="0" lang="en-PH" altLang="en-U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Text Box 17"/>
            <p:cNvSpPr txBox="1">
              <a:spLocks noChangeArrowheads="1"/>
            </p:cNvSpPr>
            <p:nvPr/>
          </p:nvSpPr>
          <p:spPr bwMode="auto">
            <a:xfrm>
              <a:off x="5023818" y="3804440"/>
              <a:ext cx="277787" cy="396931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numCol="1" anchor="t" anchorCtr="0" compatLnSpc="1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PH" altLang="en-US" sz="16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cxnSp>
          <p:nvCxnSpPr>
            <p:cNvPr id="30" name="Straight Arrow Connector 29"/>
            <p:cNvCxnSpPr/>
            <p:nvPr/>
          </p:nvCxnSpPr>
          <p:spPr>
            <a:xfrm>
              <a:off x="4620128" y="4588042"/>
              <a:ext cx="0" cy="713874"/>
            </a:xfrm>
            <a:prstGeom prst="straightConnector1">
              <a:avLst/>
            </a:prstGeom>
            <a:ln>
              <a:solidFill>
                <a:schemeClr val="tx1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Arrow Connector 30"/>
            <p:cNvCxnSpPr/>
            <p:nvPr/>
          </p:nvCxnSpPr>
          <p:spPr>
            <a:xfrm flipH="1">
              <a:off x="6970296" y="2115500"/>
              <a:ext cx="92593" cy="3186416"/>
            </a:xfrm>
            <a:prstGeom prst="straightConnector1">
              <a:avLst/>
            </a:prstGeom>
            <a:ln>
              <a:solidFill>
                <a:schemeClr val="tx1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 Box 17"/>
            <p:cNvSpPr txBox="1">
              <a:spLocks noChangeArrowheads="1"/>
            </p:cNvSpPr>
            <p:nvPr/>
          </p:nvSpPr>
          <p:spPr bwMode="auto">
            <a:xfrm>
              <a:off x="4620128" y="4746513"/>
              <a:ext cx="277787" cy="396931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numCol="1" anchor="t" anchorCtr="0" compatLnSpc="1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PH" altLang="en-US" sz="16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</a:p>
          </p:txBody>
        </p:sp>
        <p:sp>
          <p:nvSpPr>
            <p:cNvPr id="33" name="Text Box 17"/>
            <p:cNvSpPr txBox="1">
              <a:spLocks noChangeArrowheads="1"/>
            </p:cNvSpPr>
            <p:nvPr/>
          </p:nvSpPr>
          <p:spPr bwMode="auto">
            <a:xfrm>
              <a:off x="6973787" y="3612335"/>
              <a:ext cx="277787" cy="396931"/>
            </a:xfrm>
            <a:prstGeom prst="rect">
              <a:avLst/>
            </a:prstGeom>
            <a:noFill/>
            <a:ln>
              <a:noFill/>
            </a:ln>
          </p:spPr>
          <p:txBody>
            <a:bodyPr vert="horz" wrap="square" lIns="91440" tIns="45720" rIns="91440" bIns="45720" numCol="1" anchor="t" anchorCtr="0" compatLnSpc="1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en-PH" altLang="en-US" sz="16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0763718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6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jela Priency D.</dc:creator>
  <cp:lastModifiedBy>Anjela Priency D.</cp:lastModifiedBy>
  <cp:revision>1</cp:revision>
  <dcterms:created xsi:type="dcterms:W3CDTF">2021-09-02T09:29:46Z</dcterms:created>
  <dcterms:modified xsi:type="dcterms:W3CDTF">2021-09-02T09:30:00Z</dcterms:modified>
</cp:coreProperties>
</file>